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30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86A5ED-4B35-4E55-9329-8EE717C26BB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E57796-CC16-4156-8CAF-D27C0BB3D5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1318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E57796-CC16-4156-8CAF-D27C0BB3D50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1812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881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217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153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1190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1392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088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266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5530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9814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3328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9706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9AD0B-C98F-4274-83D9-896516CCC9D5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6297F-E1E2-48B4-93D3-37C43CD0C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353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1159721" y="784304"/>
            <a:ext cx="9065366" cy="1676400"/>
            <a:chOff x="1159721" y="784304"/>
            <a:chExt cx="9065366" cy="1676400"/>
          </a:xfrm>
        </p:grpSpPr>
        <p:sp>
          <p:nvSpPr>
            <p:cNvPr id="6" name="文本框 5"/>
            <p:cNvSpPr txBox="1"/>
            <p:nvPr/>
          </p:nvSpPr>
          <p:spPr>
            <a:xfrm>
              <a:off x="1159721" y="1483110"/>
              <a:ext cx="8801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6912" y="784304"/>
              <a:ext cx="8258175" cy="1676400"/>
            </a:xfrm>
            <a:prstGeom prst="rect">
              <a:avLst/>
            </a:prstGeom>
          </p:spPr>
        </p:pic>
      </p:grpSp>
      <p:grpSp>
        <p:nvGrpSpPr>
          <p:cNvPr id="12" name="组合 11"/>
          <p:cNvGrpSpPr/>
          <p:nvPr/>
        </p:nvGrpSpPr>
        <p:grpSpPr>
          <a:xfrm>
            <a:off x="676507" y="3482899"/>
            <a:ext cx="9429518" cy="1676400"/>
            <a:chOff x="676507" y="3973550"/>
            <a:chExt cx="9429518" cy="1676400"/>
          </a:xfrm>
        </p:grpSpPr>
        <p:sp>
          <p:nvSpPr>
            <p:cNvPr id="8" name="文本框 7"/>
            <p:cNvSpPr txBox="1"/>
            <p:nvPr/>
          </p:nvSpPr>
          <p:spPr>
            <a:xfrm>
              <a:off x="676507" y="4646332"/>
              <a:ext cx="8801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85975" y="3973550"/>
              <a:ext cx="8020050" cy="1676400"/>
            </a:xfrm>
            <a:prstGeom prst="rect">
              <a:avLst/>
            </a:prstGeom>
          </p:spPr>
        </p:pic>
      </p:grpSp>
      <p:sp>
        <p:nvSpPr>
          <p:cNvPr id="14" name="文本框 13"/>
          <p:cNvSpPr txBox="1"/>
          <p:nvPr/>
        </p:nvSpPr>
        <p:spPr>
          <a:xfrm>
            <a:off x="2025007" y="5765180"/>
            <a:ext cx="1009636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Sensitivity analysis of randomized controlled trials and cohort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</a:p>
          <a:p>
            <a:pPr>
              <a:lnSpc>
                <a:spcPct val="150000"/>
              </a:lnSpc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andomized controlled trials; B: cohort studies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4158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27</Words>
  <Application>Microsoft Office PowerPoint</Application>
  <PresentationFormat>宽屏</PresentationFormat>
  <Paragraphs>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>PKUI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i Sanbao</dc:creator>
  <cp:lastModifiedBy>Chai Sanbao</cp:lastModifiedBy>
  <cp:revision>3</cp:revision>
  <dcterms:created xsi:type="dcterms:W3CDTF">2023-03-10T06:04:26Z</dcterms:created>
  <dcterms:modified xsi:type="dcterms:W3CDTF">2023-03-10T06:38:58Z</dcterms:modified>
</cp:coreProperties>
</file>